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nrique María Mateu de Antonio" userId="678ddb83-0020-4a06-85d2-928a222534ef" providerId="ADAL" clId="{3BA7D094-9799-430B-A164-4677EFBEED4A}"/>
    <pc:docChg chg="modSld">
      <pc:chgData name="Enrique María Mateu de Antonio" userId="678ddb83-0020-4a06-85d2-928a222534ef" providerId="ADAL" clId="{3BA7D094-9799-430B-A164-4677EFBEED4A}" dt="2025-04-22T12:46:28.709" v="1" actId="404"/>
      <pc:docMkLst>
        <pc:docMk/>
      </pc:docMkLst>
      <pc:sldChg chg="modSp mod">
        <pc:chgData name="Enrique María Mateu de Antonio" userId="678ddb83-0020-4a06-85d2-928a222534ef" providerId="ADAL" clId="{3BA7D094-9799-430B-A164-4677EFBEED4A}" dt="2025-04-22T12:46:28.709" v="1" actId="404"/>
        <pc:sldMkLst>
          <pc:docMk/>
          <pc:sldMk cId="903095763" sldId="256"/>
        </pc:sldMkLst>
        <pc:spChg chg="mod">
          <ac:chgData name="Enrique María Mateu de Antonio" userId="678ddb83-0020-4a06-85d2-928a222534ef" providerId="ADAL" clId="{3BA7D094-9799-430B-A164-4677EFBEED4A}" dt="2025-04-22T12:46:28.709" v="1" actId="404"/>
          <ac:spMkLst>
            <pc:docMk/>
            <pc:sldMk cId="903095763" sldId="256"/>
            <ac:spMk id="3" creationId="{EDA72920-2C1C-9B29-F195-083D68CC573A}"/>
          </ac:spMkLst>
        </pc:spChg>
      </pc:sldChg>
    </pc:docChg>
  </pc:docChgLst>
  <pc:docChgLst>
    <pc:chgData name="Enrique María Mateu de Antonio" userId="678ddb83-0020-4a06-85d2-928a222534ef" providerId="ADAL" clId="{50B45F52-2087-4899-88BD-93D4D2A52E92}"/>
    <pc:docChg chg="custSel modSld">
      <pc:chgData name="Enrique María Mateu de Antonio" userId="678ddb83-0020-4a06-85d2-928a222534ef" providerId="ADAL" clId="{50B45F52-2087-4899-88BD-93D4D2A52E92}" dt="2025-02-05T14:01:50.223" v="1"/>
      <pc:docMkLst>
        <pc:docMk/>
      </pc:docMkLst>
      <pc:sldChg chg="addSp delSp modSp mod">
        <pc:chgData name="Enrique María Mateu de Antonio" userId="678ddb83-0020-4a06-85d2-928a222534ef" providerId="ADAL" clId="{50B45F52-2087-4899-88BD-93D4D2A52E92}" dt="2025-02-05T14:01:50.223" v="1"/>
        <pc:sldMkLst>
          <pc:docMk/>
          <pc:sldMk cId="903095763" sldId="256"/>
        </pc:sldMkLst>
        <pc:graphicFrameChg chg="add mod">
          <ac:chgData name="Enrique María Mateu de Antonio" userId="678ddb83-0020-4a06-85d2-928a222534ef" providerId="ADAL" clId="{50B45F52-2087-4899-88BD-93D4D2A52E92}" dt="2025-02-05T14:01:50.223" v="1"/>
          <ac:graphicFrameMkLst>
            <pc:docMk/>
            <pc:sldMk cId="903095763" sldId="256"/>
            <ac:graphicFrameMk id="5" creationId="{04760905-427A-3D3D-6251-A7F0A6269384}"/>
          </ac:graphicFrameMkLst>
        </pc:graphicFrameChg>
      </pc:sldChg>
    </pc:docChg>
  </pc:docChgLst>
  <pc:docChgLst>
    <pc:chgData name="Enrique María Mateu de Antonio" userId="678ddb83-0020-4a06-85d2-928a222534ef" providerId="ADAL" clId="{A601CADE-5D45-431B-9FAD-1293E5CA9FE7}"/>
    <pc:docChg chg="modSld">
      <pc:chgData name="Enrique María Mateu de Antonio" userId="678ddb83-0020-4a06-85d2-928a222534ef" providerId="ADAL" clId="{A601CADE-5D45-431B-9FAD-1293E5CA9FE7}" dt="2025-04-07T13:43:20.143" v="13" actId="1076"/>
      <pc:docMkLst>
        <pc:docMk/>
      </pc:docMkLst>
      <pc:sldChg chg="addSp modSp mod">
        <pc:chgData name="Enrique María Mateu de Antonio" userId="678ddb83-0020-4a06-85d2-928a222534ef" providerId="ADAL" clId="{A601CADE-5D45-431B-9FAD-1293E5CA9FE7}" dt="2025-04-07T13:43:20.143" v="13" actId="1076"/>
        <pc:sldMkLst>
          <pc:docMk/>
          <pc:sldMk cId="903095763" sldId="256"/>
        </pc:sldMkLst>
        <pc:spChg chg="add mod">
          <ac:chgData name="Enrique María Mateu de Antonio" userId="678ddb83-0020-4a06-85d2-928a222534ef" providerId="ADAL" clId="{A601CADE-5D45-431B-9FAD-1293E5CA9FE7}" dt="2025-04-07T13:43:20.143" v="13" actId="1076"/>
          <ac:spMkLst>
            <pc:docMk/>
            <pc:sldMk cId="903095763" sldId="256"/>
            <ac:spMk id="3" creationId="{EDA72920-2C1C-9B29-F195-083D68CC573A}"/>
          </ac:spMkLst>
        </pc:spChg>
        <pc:graphicFrameChg chg="mod">
          <ac:chgData name="Enrique María Mateu de Antonio" userId="678ddb83-0020-4a06-85d2-928a222534ef" providerId="ADAL" clId="{A601CADE-5D45-431B-9FAD-1293E5CA9FE7}" dt="2025-04-07T13:42:45.552" v="4" actId="1076"/>
          <ac:graphicFrameMkLst>
            <pc:docMk/>
            <pc:sldMk cId="903095763" sldId="256"/>
            <ac:graphicFrameMk id="5" creationId="{04760905-427A-3D3D-6251-A7F0A6269384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84848728-8295-BA55-E902-2B1DF82DBF7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Subtítol 2">
            <a:extLst>
              <a:ext uri="{FF2B5EF4-FFF2-40B4-BE49-F238E27FC236}">
                <a16:creationId xmlns:a16="http://schemas.microsoft.com/office/drawing/2014/main" id="{73063782-1D95-85D2-5254-8E873C2EC5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/>
              <a:t>Feu clic aquí per editar l'estil de subtítols del patró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35BB181B-355B-32BE-6EB1-7E6A38181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E392E58D-E075-8EA8-ACC7-333689B31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5DD3F973-EA75-1004-EB8A-0E1DA5133A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0311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C6D029E0-B39A-019E-881F-6927EB19F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8FAB5F07-4CD6-2119-FF5D-A89400325E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0C9A300F-E13B-C1E4-E252-AC48566659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CF03079B-54AB-51AD-F5DC-01CED1364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58665E97-A56E-29A0-A185-1D4B459D6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73172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>
            <a:extLst>
              <a:ext uri="{FF2B5EF4-FFF2-40B4-BE49-F238E27FC236}">
                <a16:creationId xmlns:a16="http://schemas.microsoft.com/office/drawing/2014/main" id="{9EB981D6-90A6-03F6-E520-8B04269FB8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vertical 2">
            <a:extLst>
              <a:ext uri="{FF2B5EF4-FFF2-40B4-BE49-F238E27FC236}">
                <a16:creationId xmlns:a16="http://schemas.microsoft.com/office/drawing/2014/main" id="{9710EDFD-8946-FCD4-A2CC-AC15B19A97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0CF3D7C-8D50-07F5-CC37-5F72E8144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DEC8E623-E503-3042-05C7-BA0DD9B42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81F026F2-8962-7F65-4A5E-113D91525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7670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BE6F923-CE2C-78FD-2A05-C3A18FCC10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B4665CEC-0195-746C-42A3-448F0C7744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5EC05FFE-6BA6-DB5C-2C72-C6F75F3CD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F95C150B-3E3B-EA54-5C63-5C9726E2A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5DF31254-F61F-39BA-B4BE-ED284327F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5011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46227A8E-030C-6257-DB74-86ACFBF9F3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C15B3F23-7C54-4762-7F66-5727B17F2D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69980EAB-8D8D-2142-88FD-07C08EF7A3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5A722FBD-EBFD-2372-61BB-882F2396B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4260499B-E0B2-912A-95A4-3B0381AEFF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4232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364FCB13-5BBF-B036-68BF-25CBA46508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B5B7AD67-DBF3-FD68-581F-58182DF3E4C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DF1A9692-F2F5-7C4D-5410-38EC955AE1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FFFA585C-3093-F24D-99BC-EA0A974A0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DD9C9F55-49C2-F270-25B7-FC543D262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AF372527-9369-F775-E2F2-B0C94816E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0942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2FC7D75B-8EE3-15D3-5800-29E1DEF89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AE1DD6B3-1619-D292-BCCC-2C145ED803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4" name="Contenidor de contingut 3">
            <a:extLst>
              <a:ext uri="{FF2B5EF4-FFF2-40B4-BE49-F238E27FC236}">
                <a16:creationId xmlns:a16="http://schemas.microsoft.com/office/drawing/2014/main" id="{2A227C59-D375-8E18-BD7B-869B5E247E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5" name="Contenidor de text 4">
            <a:extLst>
              <a:ext uri="{FF2B5EF4-FFF2-40B4-BE49-F238E27FC236}">
                <a16:creationId xmlns:a16="http://schemas.microsoft.com/office/drawing/2014/main" id="{ED546F52-2A65-E962-5C71-8C60DB98C8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6" name="Contenidor de contingut 5">
            <a:extLst>
              <a:ext uri="{FF2B5EF4-FFF2-40B4-BE49-F238E27FC236}">
                <a16:creationId xmlns:a16="http://schemas.microsoft.com/office/drawing/2014/main" id="{98BA3932-36B2-1F51-EA0D-C630600915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7" name="Contenidor de data 6">
            <a:extLst>
              <a:ext uri="{FF2B5EF4-FFF2-40B4-BE49-F238E27FC236}">
                <a16:creationId xmlns:a16="http://schemas.microsoft.com/office/drawing/2014/main" id="{2F428C10-0AC9-860A-BAC5-EDE005FD88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8" name="Contenidor de peu de pàgina 7">
            <a:extLst>
              <a:ext uri="{FF2B5EF4-FFF2-40B4-BE49-F238E27FC236}">
                <a16:creationId xmlns:a16="http://schemas.microsoft.com/office/drawing/2014/main" id="{934ED71E-3EC0-AD17-CA38-9B7306497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Contenidor de número de diapositiva 8">
            <a:extLst>
              <a:ext uri="{FF2B5EF4-FFF2-40B4-BE49-F238E27FC236}">
                <a16:creationId xmlns:a16="http://schemas.microsoft.com/office/drawing/2014/main" id="{A9117455-A524-0FEC-5222-FDFFF2E1E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95548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D203D129-80C0-1D2E-7449-C9634D9DE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data 2">
            <a:extLst>
              <a:ext uri="{FF2B5EF4-FFF2-40B4-BE49-F238E27FC236}">
                <a16:creationId xmlns:a16="http://schemas.microsoft.com/office/drawing/2014/main" id="{0F038F22-D132-1610-1446-01B318A55D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4" name="Contenidor de peu de pàgina 3">
            <a:extLst>
              <a:ext uri="{FF2B5EF4-FFF2-40B4-BE49-F238E27FC236}">
                <a16:creationId xmlns:a16="http://schemas.microsoft.com/office/drawing/2014/main" id="{7A855420-E5EF-9271-62CA-641E37F72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Contenidor de número de diapositiva 4">
            <a:extLst>
              <a:ext uri="{FF2B5EF4-FFF2-40B4-BE49-F238E27FC236}">
                <a16:creationId xmlns:a16="http://schemas.microsoft.com/office/drawing/2014/main" id="{EF96023E-A743-BB5B-0C46-D86009BAC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9733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>
            <a:extLst>
              <a:ext uri="{FF2B5EF4-FFF2-40B4-BE49-F238E27FC236}">
                <a16:creationId xmlns:a16="http://schemas.microsoft.com/office/drawing/2014/main" id="{96234DFE-C0BD-6150-C38C-3216720E2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3" name="Contenidor de peu de pàgina 2">
            <a:extLst>
              <a:ext uri="{FF2B5EF4-FFF2-40B4-BE49-F238E27FC236}">
                <a16:creationId xmlns:a16="http://schemas.microsoft.com/office/drawing/2014/main" id="{C64B5553-F84A-67FF-DED5-7B136D21E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Contenidor de número de diapositiva 3">
            <a:extLst>
              <a:ext uri="{FF2B5EF4-FFF2-40B4-BE49-F238E27FC236}">
                <a16:creationId xmlns:a16="http://schemas.microsoft.com/office/drawing/2014/main" id="{F749E0EE-8BF9-160F-BA18-6EE3101FE2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42414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605C0CBC-1FCD-8AF8-91DE-903B010C6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contingut 2">
            <a:extLst>
              <a:ext uri="{FF2B5EF4-FFF2-40B4-BE49-F238E27FC236}">
                <a16:creationId xmlns:a16="http://schemas.microsoft.com/office/drawing/2014/main" id="{B7FA7FBA-255B-DBC4-D755-7FB638C426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B095255E-D1DC-3BF0-15C7-42A58B6CFE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8A9D61E0-E22A-D952-7EEB-735AF856A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591B1DF1-7CEA-3952-7B46-622B00722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82B5968C-F37F-1539-C08F-F888B2BB2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82449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>
            <a:extLst>
              <a:ext uri="{FF2B5EF4-FFF2-40B4-BE49-F238E27FC236}">
                <a16:creationId xmlns:a16="http://schemas.microsoft.com/office/drawing/2014/main" id="{E9053440-84C1-03DD-3B36-0D73369690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'imatge 2">
            <a:extLst>
              <a:ext uri="{FF2B5EF4-FFF2-40B4-BE49-F238E27FC236}">
                <a16:creationId xmlns:a16="http://schemas.microsoft.com/office/drawing/2014/main" id="{119100DA-1756-A26F-FAA5-F853B0EC4B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Contenidor de text 3">
            <a:extLst>
              <a:ext uri="{FF2B5EF4-FFF2-40B4-BE49-F238E27FC236}">
                <a16:creationId xmlns:a16="http://schemas.microsoft.com/office/drawing/2014/main" id="{3DF0AF9D-FAD5-9801-41CE-8A8964A924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/>
              <a:t>Feu clic per editar els estils del text del patró</a:t>
            </a:r>
          </a:p>
        </p:txBody>
      </p:sp>
      <p:sp>
        <p:nvSpPr>
          <p:cNvPr id="5" name="Contenidor de data 4">
            <a:extLst>
              <a:ext uri="{FF2B5EF4-FFF2-40B4-BE49-F238E27FC236}">
                <a16:creationId xmlns:a16="http://schemas.microsoft.com/office/drawing/2014/main" id="{BA77345E-FCF0-3EDC-12A3-75962D015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6" name="Contenidor de peu de pàgina 5">
            <a:extLst>
              <a:ext uri="{FF2B5EF4-FFF2-40B4-BE49-F238E27FC236}">
                <a16:creationId xmlns:a16="http://schemas.microsoft.com/office/drawing/2014/main" id="{C13EF739-2673-7E31-99AD-302636C60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Contenidor de número de diapositiva 6">
            <a:extLst>
              <a:ext uri="{FF2B5EF4-FFF2-40B4-BE49-F238E27FC236}">
                <a16:creationId xmlns:a16="http://schemas.microsoft.com/office/drawing/2014/main" id="{67688BE0-0B9B-4978-83E5-FD7378CBD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9899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>
            <a:extLst>
              <a:ext uri="{FF2B5EF4-FFF2-40B4-BE49-F238E27FC236}">
                <a16:creationId xmlns:a16="http://schemas.microsoft.com/office/drawing/2014/main" id="{0BE10D0F-D619-D98B-9A90-D10F87BB38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/>
              <a:t>Feu clic aquí per editar l'estil</a:t>
            </a:r>
            <a:endParaRPr lang="es-ES"/>
          </a:p>
        </p:txBody>
      </p:sp>
      <p:sp>
        <p:nvSpPr>
          <p:cNvPr id="3" name="Contenidor de text 2">
            <a:extLst>
              <a:ext uri="{FF2B5EF4-FFF2-40B4-BE49-F238E27FC236}">
                <a16:creationId xmlns:a16="http://schemas.microsoft.com/office/drawing/2014/main" id="{4B9216DF-64F1-6461-5B0C-8F70E486B3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/>
              <a:t>Feu clic per editar els estils del text del patró</a:t>
            </a:r>
          </a:p>
          <a:p>
            <a:pPr lvl="1"/>
            <a:r>
              <a:rPr lang="ca-ES"/>
              <a:t>Segon nivell</a:t>
            </a:r>
          </a:p>
          <a:p>
            <a:pPr lvl="2"/>
            <a:r>
              <a:rPr lang="ca-ES"/>
              <a:t>Tercer nivell</a:t>
            </a:r>
          </a:p>
          <a:p>
            <a:pPr lvl="3"/>
            <a:r>
              <a:rPr lang="ca-ES"/>
              <a:t>Quart nivell</a:t>
            </a:r>
          </a:p>
          <a:p>
            <a:pPr lvl="4"/>
            <a:r>
              <a:rPr lang="ca-ES"/>
              <a:t>Cinquè nivell</a:t>
            </a:r>
            <a:endParaRPr lang="es-ES"/>
          </a:p>
        </p:txBody>
      </p:sp>
      <p:sp>
        <p:nvSpPr>
          <p:cNvPr id="4" name="Contenidor de data 3">
            <a:extLst>
              <a:ext uri="{FF2B5EF4-FFF2-40B4-BE49-F238E27FC236}">
                <a16:creationId xmlns:a16="http://schemas.microsoft.com/office/drawing/2014/main" id="{96B16E22-ADA3-9CF5-C643-F45F8E9D5D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65CC860-837F-4F57-93D2-F1065AAD83C5}" type="datetimeFigureOut">
              <a:rPr lang="es-ES" smtClean="0"/>
              <a:t>22/04/2025</a:t>
            </a:fld>
            <a:endParaRPr lang="es-ES"/>
          </a:p>
        </p:txBody>
      </p:sp>
      <p:sp>
        <p:nvSpPr>
          <p:cNvPr id="5" name="Contenidor de peu de pàgina 4">
            <a:extLst>
              <a:ext uri="{FF2B5EF4-FFF2-40B4-BE49-F238E27FC236}">
                <a16:creationId xmlns:a16="http://schemas.microsoft.com/office/drawing/2014/main" id="{2861D52D-D466-B008-A964-20FEF460E7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Contenidor de número de diapositiva 5">
            <a:extLst>
              <a:ext uri="{FF2B5EF4-FFF2-40B4-BE49-F238E27FC236}">
                <a16:creationId xmlns:a16="http://schemas.microsoft.com/office/drawing/2014/main" id="{4F3268E6-71BA-259E-24A6-CB938F280F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0343AB-F1B5-4ACF-AC56-7AAFAE986F59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7357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e 4">
            <a:extLst>
              <a:ext uri="{FF2B5EF4-FFF2-40B4-BE49-F238E27FC236}">
                <a16:creationId xmlns:a16="http://schemas.microsoft.com/office/drawing/2014/main" id="{04760905-427A-3D3D-6251-A7F0A62693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0050676"/>
              </p:ext>
            </p:extLst>
          </p:nvPr>
        </p:nvGraphicFramePr>
        <p:xfrm>
          <a:off x="3116263" y="1071564"/>
          <a:ext cx="6264711" cy="5453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8494881" imgH="7394683" progId="Prism10.Document">
                  <p:embed/>
                </p:oleObj>
              </mc:Choice>
              <mc:Fallback>
                <p:oleObj name="Prism 10" r:id="rId2" imgW="8494881" imgH="7394683" progId="Prism10.Document">
                  <p:embed/>
                  <p:pic>
                    <p:nvPicPr>
                      <p:cNvPr id="5" name="Objecte 4">
                        <a:extLst>
                          <a:ext uri="{FF2B5EF4-FFF2-40B4-BE49-F238E27FC236}">
                            <a16:creationId xmlns:a16="http://schemas.microsoft.com/office/drawing/2014/main" id="{04760905-427A-3D3D-6251-A7F0A62693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16263" y="1071564"/>
                        <a:ext cx="6264711" cy="5453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QuadreDeText 2">
            <a:extLst>
              <a:ext uri="{FF2B5EF4-FFF2-40B4-BE49-F238E27FC236}">
                <a16:creationId xmlns:a16="http://schemas.microsoft.com/office/drawing/2014/main" id="{EDA72920-2C1C-9B29-F195-083D68CC573A}"/>
              </a:ext>
            </a:extLst>
          </p:cNvPr>
          <p:cNvSpPr txBox="1"/>
          <p:nvPr/>
        </p:nvSpPr>
        <p:spPr>
          <a:xfrm>
            <a:off x="319087" y="128994"/>
            <a:ext cx="11553825" cy="6131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Supplementary material 2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Distribution of rectal temperatures per day and group between 2 days post-challenge (DPC) until 10 DPC. NV/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NC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= non-vaccinated/non-challenged; NV/Ch = non vaccinated/challenged, Por =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Porcilis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PRRS vaccinated/challenged, IL =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Innovac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Times New Roman" panose="02020603050405020304" pitchFamily="18" charset="0"/>
              </a:rPr>
              <a:t> L vaccinated/challenged. * = p&lt;0.05; ** = p&lt;0.01; *** = p&lt;0.001.</a:t>
            </a:r>
            <a:endParaRPr lang="es-ES" sz="1200" kern="1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30957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icina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icina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4</Words>
  <Application>Microsoft Office PowerPoint</Application>
  <PresentationFormat>Pantalla panoràmica</PresentationFormat>
  <Paragraphs>1</Paragraphs>
  <Slides>1</Slides>
  <Notes>0</Notes>
  <HiddenSlides>0</HiddenSlides>
  <MMClips>0</MMClips>
  <ScaleCrop>false</ScaleCrop>
  <HeadingPairs>
    <vt:vector size="8" baseType="variant">
      <vt:variant>
        <vt:lpstr>Tipus de lletra utilitzats</vt:lpstr>
      </vt:variant>
      <vt:variant>
        <vt:i4>4</vt:i4>
      </vt:variant>
      <vt:variant>
        <vt:lpstr>Tema</vt:lpstr>
      </vt:variant>
      <vt:variant>
        <vt:i4>1</vt:i4>
      </vt:variant>
      <vt:variant>
        <vt:lpstr>Servidors OLE incrustats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Tema de l'Office</vt:lpstr>
      <vt:lpstr>Prism 10</vt:lpstr>
      <vt:lpstr>Presentació del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nrique María Mateu de Antonio</dc:creator>
  <cp:lastModifiedBy>Enrique María Mateu de Antonio</cp:lastModifiedBy>
  <cp:revision>1</cp:revision>
  <dcterms:created xsi:type="dcterms:W3CDTF">2025-02-05T13:58:59Z</dcterms:created>
  <dcterms:modified xsi:type="dcterms:W3CDTF">2025-04-22T12:46:28Z</dcterms:modified>
</cp:coreProperties>
</file>